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170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EA17C-D222-4344-82FB-F2E7FB7F5395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E5262-AFAC-4820-AE1A-FE99A2BCCE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1696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EA17C-D222-4344-82FB-F2E7FB7F5395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E5262-AFAC-4820-AE1A-FE99A2BCCE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49000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EA17C-D222-4344-82FB-F2E7FB7F5395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E5262-AFAC-4820-AE1A-FE99A2BCCE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61514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EA17C-D222-4344-82FB-F2E7FB7F5395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E5262-AFAC-4820-AE1A-FE99A2BCCE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46333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EA17C-D222-4344-82FB-F2E7FB7F5395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E5262-AFAC-4820-AE1A-FE99A2BCCE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0616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EA17C-D222-4344-82FB-F2E7FB7F5395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E5262-AFAC-4820-AE1A-FE99A2BCCE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16301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EA17C-D222-4344-82FB-F2E7FB7F5395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E5262-AFAC-4820-AE1A-FE99A2BCCE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3323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EA17C-D222-4344-82FB-F2E7FB7F5395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E5262-AFAC-4820-AE1A-FE99A2BCCE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21893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EA17C-D222-4344-82FB-F2E7FB7F5395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E5262-AFAC-4820-AE1A-FE99A2BCCE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08798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EA17C-D222-4344-82FB-F2E7FB7F5395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E5262-AFAC-4820-AE1A-FE99A2BCCE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44070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EA17C-D222-4344-82FB-F2E7FB7F5395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E5262-AFAC-4820-AE1A-FE99A2BCCE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96006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DEA17C-D222-4344-82FB-F2E7FB7F5395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0E5262-AFAC-4820-AE1A-FE99A2BCCE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717527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 descr="스크린샷, 지도이(가) 표시된 사진&#10;&#10;자동 생성된 설명">
            <a:extLst>
              <a:ext uri="{FF2B5EF4-FFF2-40B4-BE49-F238E27FC236}">
                <a16:creationId xmlns:a16="http://schemas.microsoft.com/office/drawing/2014/main" id="{B4040A6E-A902-436E-85C1-B56865D1325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34518"/>
            <a:ext cx="9144000" cy="5388864"/>
          </a:xfrm>
          <a:prstGeom prst="rect">
            <a:avLst/>
          </a:prstGeom>
        </p:spPr>
      </p:pic>
      <p:sp>
        <p:nvSpPr>
          <p:cNvPr id="4" name="직사각형 3">
            <a:extLst>
              <a:ext uri="{FF2B5EF4-FFF2-40B4-BE49-F238E27FC236}">
                <a16:creationId xmlns:a16="http://schemas.microsoft.com/office/drawing/2014/main" id="{013E7395-AB79-4DDA-9778-C313D5F18819}"/>
              </a:ext>
            </a:extLst>
          </p:cNvPr>
          <p:cNvSpPr/>
          <p:nvPr/>
        </p:nvSpPr>
        <p:spPr>
          <a:xfrm>
            <a:off x="0" y="5846151"/>
            <a:ext cx="9144000" cy="1011849"/>
          </a:xfrm>
          <a:prstGeom prst="rect">
            <a:avLst/>
          </a:prstGeom>
        </p:spPr>
        <p:txBody>
          <a:bodyPr wrap="square">
            <a:noAutofit/>
          </a:bodyPr>
          <a:lstStyle/>
          <a:p>
            <a:pPr algn="just"/>
            <a:r>
              <a:rPr lang="en-US" altLang="ko-KR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Fig </a:t>
            </a:r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5. GWAS analysis of SP1 locus and structural comparisons of CaaXEP gene and protein.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Comparison of the green seed coat-linked GWAS analyses and consistency of the Manhattan plots between the WGR data (248 soybean accessions) and SoySNP50K data (10312 soybean accessions). Color-coded circles indicate the functional impacts of variants, as denoted in Figure 2. In the magnified image, Glyma.01G198500 (CaaX-type endopeptidase; CaaXEP) was expected to be a candidate with the most functionally significant variation and thereby further analyzed. (B) Comparison of transcriptome-based gene models for the CaaXEP. Each CaaXEP gene model for the yellow (upper) or green (below) soybean was depicted along with the RNA-seq read depths. (C) Modeling-based prediction of the 3D-structures and comparison of the CaaXEP proteins.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48435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</TotalTime>
  <Words>149</Words>
  <Application>Microsoft Office PowerPoint</Application>
  <PresentationFormat>화면 슬라이드 쇼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진현 김</dc:creator>
  <cp:lastModifiedBy>김 진현</cp:lastModifiedBy>
  <cp:revision>13</cp:revision>
  <dcterms:created xsi:type="dcterms:W3CDTF">2019-01-03T06:19:06Z</dcterms:created>
  <dcterms:modified xsi:type="dcterms:W3CDTF">2020-04-24T15:39:11Z</dcterms:modified>
</cp:coreProperties>
</file>